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454" r:id="rId2"/>
    <p:sldId id="462" r:id="rId3"/>
    <p:sldId id="498" r:id="rId4"/>
    <p:sldId id="497" r:id="rId5"/>
  </p:sldIdLst>
  <p:sldSz cx="9144000" cy="6858000" type="screen4x3"/>
  <p:notesSz cx="7023100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2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936" y="1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E88E5331-64C8-4241-8694-4A57A70D8CFC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4275" y="698500"/>
            <a:ext cx="4654550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21823"/>
            <a:ext cx="5618480" cy="4189095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29"/>
            <a:ext cx="3043343" cy="465455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4566CDC7-B3A5-4278-98E6-76D1063757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7486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4275" y="698500"/>
            <a:ext cx="4654550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929468-0936-4C63-B815-A3E737EFADD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0995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4275" y="698500"/>
            <a:ext cx="4654550" cy="34909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. 6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25D9E73-81FC-4137-9155-9164717E07F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548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419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358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942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455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363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639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169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501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311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348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8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2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960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73468-C24C-499C-9AB8-E88722EFA98A}" type="datetimeFigureOut">
              <a:rPr lang="en-US" smtClean="0"/>
              <a:t>1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468E0-B7D6-4509-9CCE-ABDA7DFB4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053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8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2" indent="-342892" algn="l" defTabSz="914378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1" indent="-285743" algn="l" defTabSz="914378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28"/>
          <p:cNvSpPr txBox="1">
            <a:spLocks noChangeArrowheads="1"/>
          </p:cNvSpPr>
          <p:nvPr/>
        </p:nvSpPr>
        <p:spPr bwMode="auto">
          <a:xfrm>
            <a:off x="459393" y="2340724"/>
            <a:ext cx="7969384" cy="13849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of GFP-p1380N-Cas9/sgRNA:cslob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MV 35S and 35T, the cauliflower mosaic virus 35S promoter and its terminator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s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NosT, the nopaline synthase gene promoter and its terminator; LB and RB, the left and right borders of the T-DNA region; Flag-Cas9-NLS, the Cas9 endonuclease containing Flag tag at its N-terminal and nuclear location signal at its C-terminal; target, the 20 nucleotide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LOB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ghlighted by red, was conserved on both alleles; sgRNA scaffold, a synthetic single-guide RNA composed of a fusion of CRISPR RNA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vating CRISPR RNA; NptII, neomycin phosphotransferase II; GFP, green fluorescent protein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sVMV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cassava vein mosaic virus promoter; PAM, protospacer-adjacent motif.  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0" y="1095422"/>
            <a:ext cx="9144000" cy="897946"/>
            <a:chOff x="0" y="1095422"/>
            <a:chExt cx="9144000" cy="897946"/>
          </a:xfrm>
        </p:grpSpPr>
        <p:sp>
          <p:nvSpPr>
            <p:cNvPr id="109" name="Rectangle 108"/>
            <p:cNvSpPr/>
            <p:nvPr/>
          </p:nvSpPr>
          <p:spPr>
            <a:xfrm>
              <a:off x="8448209" y="1097531"/>
              <a:ext cx="695791" cy="4572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100" b="1" dirty="0" smtClean="0"/>
                <a:t>LB</a:t>
              </a:r>
              <a:endParaRPr lang="en-US" sz="1100" b="1" dirty="0"/>
            </a:p>
          </p:txBody>
        </p:sp>
        <p:grpSp>
          <p:nvGrpSpPr>
            <p:cNvPr id="7" name="Group 6"/>
            <p:cNvGrpSpPr/>
            <p:nvPr/>
          </p:nvGrpSpPr>
          <p:grpSpPr>
            <a:xfrm>
              <a:off x="0" y="1095422"/>
              <a:ext cx="8838672" cy="897946"/>
              <a:chOff x="124734" y="4309677"/>
              <a:chExt cx="8838672" cy="897946"/>
            </a:xfrm>
          </p:grpSpPr>
          <p:sp>
            <p:nvSpPr>
              <p:cNvPr id="108" name="Rectangle 107"/>
              <p:cNvSpPr/>
              <p:nvPr/>
            </p:nvSpPr>
            <p:spPr>
              <a:xfrm>
                <a:off x="124734" y="4329800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smtClean="0"/>
                  <a:t>RB</a:t>
                </a:r>
                <a:endParaRPr lang="en-US" sz="1100" b="1" dirty="0"/>
              </a:p>
            </p:txBody>
          </p:sp>
          <p:cxnSp>
            <p:nvCxnSpPr>
              <p:cNvPr id="86" name="Straight Connector 85"/>
              <p:cNvCxnSpPr/>
              <p:nvPr/>
            </p:nvCxnSpPr>
            <p:spPr>
              <a:xfrm>
                <a:off x="4679943" y="4549164"/>
                <a:ext cx="76200" cy="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Rectangle 88"/>
              <p:cNvSpPr/>
              <p:nvPr/>
            </p:nvSpPr>
            <p:spPr>
              <a:xfrm>
                <a:off x="2196239" y="4396764"/>
                <a:ext cx="723900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93" name="Rectangle 92"/>
              <p:cNvSpPr/>
              <p:nvPr/>
            </p:nvSpPr>
            <p:spPr>
              <a:xfrm>
                <a:off x="4305987" y="4396764"/>
                <a:ext cx="361309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95" name="Rectangle 94"/>
              <p:cNvSpPr/>
              <p:nvPr/>
            </p:nvSpPr>
            <p:spPr>
              <a:xfrm>
                <a:off x="2920139" y="4396764"/>
                <a:ext cx="1385848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4756143" y="4396764"/>
                <a:ext cx="723900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97" name="Rectangle 96"/>
              <p:cNvSpPr/>
              <p:nvPr/>
            </p:nvSpPr>
            <p:spPr>
              <a:xfrm>
                <a:off x="6816473" y="4396764"/>
                <a:ext cx="405286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98" name="Rectangle 97"/>
              <p:cNvSpPr/>
              <p:nvPr/>
            </p:nvSpPr>
            <p:spPr>
              <a:xfrm>
                <a:off x="5906413" y="4396764"/>
                <a:ext cx="910059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99" name="Rectangle 98"/>
              <p:cNvSpPr/>
              <p:nvPr/>
            </p:nvSpPr>
            <p:spPr>
              <a:xfrm>
                <a:off x="7330788" y="4396764"/>
                <a:ext cx="457200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100" name="Rectangle 99"/>
              <p:cNvSpPr/>
              <p:nvPr/>
            </p:nvSpPr>
            <p:spPr>
              <a:xfrm>
                <a:off x="8456597" y="4396764"/>
                <a:ext cx="299357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101" name="Rectangle 100"/>
              <p:cNvSpPr/>
              <p:nvPr/>
            </p:nvSpPr>
            <p:spPr>
              <a:xfrm>
                <a:off x="7814867" y="4396764"/>
                <a:ext cx="640080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102" name="Rectangle 101"/>
              <p:cNvSpPr/>
              <p:nvPr/>
            </p:nvSpPr>
            <p:spPr>
              <a:xfrm>
                <a:off x="2136369" y="4320564"/>
                <a:ext cx="838199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CaMV</a:t>
                </a:r>
                <a:r>
                  <a:rPr lang="en-US" sz="1100" b="1" dirty="0" smtClean="0"/>
                  <a:t> 35S</a:t>
                </a:r>
                <a:endParaRPr lang="en-US" sz="1100" b="1" dirty="0"/>
              </a:p>
            </p:txBody>
          </p:sp>
          <p:sp>
            <p:nvSpPr>
              <p:cNvPr id="103" name="Rectangle 102"/>
              <p:cNvSpPr/>
              <p:nvPr/>
            </p:nvSpPr>
            <p:spPr>
              <a:xfrm>
                <a:off x="2863764" y="4342335"/>
                <a:ext cx="1580375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b="1" dirty="0" smtClean="0"/>
                  <a:t>Flag-Cas9-NLS</a:t>
                </a:r>
                <a:endParaRPr lang="en-US" sz="1200" b="1" dirty="0"/>
              </a:p>
            </p:txBody>
          </p:sp>
          <p:sp>
            <p:nvSpPr>
              <p:cNvPr id="104" name="Rectangle 103"/>
              <p:cNvSpPr/>
              <p:nvPr/>
            </p:nvSpPr>
            <p:spPr>
              <a:xfrm>
                <a:off x="4139341" y="4320564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NosT</a:t>
                </a:r>
                <a:endParaRPr lang="en-US" sz="1100" b="1" dirty="0"/>
              </a:p>
            </p:txBody>
          </p:sp>
          <p:cxnSp>
            <p:nvCxnSpPr>
              <p:cNvPr id="105" name="Straight Connector 104"/>
              <p:cNvCxnSpPr/>
              <p:nvPr/>
            </p:nvCxnSpPr>
            <p:spPr>
              <a:xfrm>
                <a:off x="7230818" y="4549164"/>
                <a:ext cx="91440" cy="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2114597" y="4549164"/>
                <a:ext cx="76200" cy="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/>
              <p:cNvCxnSpPr/>
              <p:nvPr/>
            </p:nvCxnSpPr>
            <p:spPr>
              <a:xfrm>
                <a:off x="8759747" y="4549164"/>
                <a:ext cx="76200" cy="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Rectangle 109"/>
              <p:cNvSpPr/>
              <p:nvPr/>
            </p:nvSpPr>
            <p:spPr>
              <a:xfrm>
                <a:off x="4567545" y="4320564"/>
                <a:ext cx="1077686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CaMV</a:t>
                </a:r>
                <a:r>
                  <a:rPr lang="en-US" sz="1100" b="1" dirty="0" smtClean="0"/>
                  <a:t> 35S</a:t>
                </a:r>
                <a:endParaRPr lang="en-US" sz="1100" b="1" dirty="0"/>
              </a:p>
            </p:txBody>
          </p:sp>
          <p:sp>
            <p:nvSpPr>
              <p:cNvPr id="111" name="Rectangle 110"/>
              <p:cNvSpPr/>
              <p:nvPr/>
            </p:nvSpPr>
            <p:spPr>
              <a:xfrm>
                <a:off x="6662036" y="4320564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NosT</a:t>
                </a:r>
                <a:endParaRPr lang="en-US" sz="1100" b="1" dirty="0"/>
              </a:p>
            </p:txBody>
          </p:sp>
          <p:sp>
            <p:nvSpPr>
              <p:cNvPr id="112" name="Rectangle 111"/>
              <p:cNvSpPr/>
              <p:nvPr/>
            </p:nvSpPr>
            <p:spPr>
              <a:xfrm>
                <a:off x="7213387" y="4320564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NosP</a:t>
                </a:r>
                <a:endParaRPr lang="en-US" sz="1100" b="1" dirty="0"/>
              </a:p>
            </p:txBody>
          </p:sp>
          <p:sp>
            <p:nvSpPr>
              <p:cNvPr id="113" name="Rectangle 112"/>
              <p:cNvSpPr/>
              <p:nvPr/>
            </p:nvSpPr>
            <p:spPr>
              <a:xfrm>
                <a:off x="7464347" y="4309677"/>
                <a:ext cx="1338943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NptII</a:t>
                </a:r>
                <a:endParaRPr lang="en-US" sz="1100" b="1" dirty="0"/>
              </a:p>
            </p:txBody>
          </p:sp>
          <p:sp>
            <p:nvSpPr>
              <p:cNvPr id="114" name="Rectangle 113"/>
              <p:cNvSpPr/>
              <p:nvPr/>
            </p:nvSpPr>
            <p:spPr>
              <a:xfrm>
                <a:off x="8267615" y="4342335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smtClean="0"/>
                  <a:t>35T</a:t>
                </a:r>
                <a:endParaRPr lang="en-US" sz="1100" b="1" dirty="0"/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5572573" y="4342335"/>
                <a:ext cx="1580375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sgRNA</a:t>
                </a:r>
                <a:r>
                  <a:rPr lang="en-US" sz="1100" b="1" dirty="0" smtClean="0"/>
                  <a:t> scaffold</a:t>
                </a:r>
                <a:endParaRPr lang="en-US" sz="1100" b="1" dirty="0"/>
              </a:p>
            </p:txBody>
          </p:sp>
          <p:sp>
            <p:nvSpPr>
              <p:cNvPr id="65" name="Rectangle 64"/>
              <p:cNvSpPr/>
              <p:nvPr/>
            </p:nvSpPr>
            <p:spPr>
              <a:xfrm>
                <a:off x="5480043" y="4396764"/>
                <a:ext cx="426371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5350757" y="4342335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smtClean="0"/>
                  <a:t>Target</a:t>
                </a:r>
                <a:endParaRPr lang="en-US" sz="1100" b="1" dirty="0"/>
              </a:p>
            </p:txBody>
          </p:sp>
          <p:grpSp>
            <p:nvGrpSpPr>
              <p:cNvPr id="72" name="Group 71"/>
              <p:cNvGrpSpPr/>
              <p:nvPr/>
            </p:nvGrpSpPr>
            <p:grpSpPr>
              <a:xfrm>
                <a:off x="4798566" y="4701565"/>
                <a:ext cx="2261133" cy="506058"/>
                <a:chOff x="4976926" y="2318919"/>
                <a:chExt cx="2261133" cy="506058"/>
              </a:xfrm>
            </p:grpSpPr>
            <p:sp>
              <p:nvSpPr>
                <p:cNvPr id="73" name="Right Brace 72"/>
                <p:cNvSpPr/>
                <p:nvPr/>
              </p:nvSpPr>
              <p:spPr>
                <a:xfrm rot="16200000">
                  <a:off x="5832344" y="1594280"/>
                  <a:ext cx="195940" cy="1645217"/>
                </a:xfrm>
                <a:prstGeom prst="rightBrac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b="1"/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4976926" y="2455645"/>
                  <a:ext cx="226113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 smtClean="0">
                      <a:solidFill>
                        <a:schemeClr val="accent3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900" b="1" dirty="0">
                      <a:solidFill>
                        <a:srgbClr val="C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TATAGGCGGCGGAGAGAG</a:t>
                  </a:r>
                  <a:r>
                    <a:rPr lang="en-US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GG</a:t>
                  </a:r>
                </a:p>
                <a:p>
                  <a:r>
                    <a:rPr lang="en-US" sz="9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                                             PAM</a:t>
                  </a:r>
                  <a:endParaRPr lang="en-US" sz="9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15" name="Rectangle 114"/>
              <p:cNvSpPr/>
              <p:nvPr/>
            </p:nvSpPr>
            <p:spPr>
              <a:xfrm>
                <a:off x="646545" y="4396764"/>
                <a:ext cx="498764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116" name="Rectangle 115"/>
              <p:cNvSpPr/>
              <p:nvPr/>
            </p:nvSpPr>
            <p:spPr>
              <a:xfrm>
                <a:off x="1817711" y="4396764"/>
                <a:ext cx="299357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117" name="Rectangle 116"/>
              <p:cNvSpPr/>
              <p:nvPr/>
            </p:nvSpPr>
            <p:spPr>
              <a:xfrm>
                <a:off x="1166745" y="4396764"/>
                <a:ext cx="640080" cy="304800"/>
              </a:xfrm>
              <a:prstGeom prst="rect">
                <a:avLst/>
              </a:pr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cxnSp>
            <p:nvCxnSpPr>
              <p:cNvPr id="118" name="Straight Connector 117"/>
              <p:cNvCxnSpPr/>
              <p:nvPr/>
            </p:nvCxnSpPr>
            <p:spPr>
              <a:xfrm>
                <a:off x="554988" y="4549164"/>
                <a:ext cx="91440" cy="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Rectangle 119"/>
              <p:cNvSpPr/>
              <p:nvPr/>
            </p:nvSpPr>
            <p:spPr>
              <a:xfrm>
                <a:off x="556029" y="4320564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err="1" smtClean="0"/>
                  <a:t>CsVMV</a:t>
                </a:r>
                <a:endParaRPr lang="en-US" sz="1100" b="1" dirty="0"/>
              </a:p>
            </p:txBody>
          </p:sp>
          <p:sp>
            <p:nvSpPr>
              <p:cNvPr id="121" name="Rectangle 120"/>
              <p:cNvSpPr/>
              <p:nvPr/>
            </p:nvSpPr>
            <p:spPr>
              <a:xfrm>
                <a:off x="806989" y="4309677"/>
                <a:ext cx="1338943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smtClean="0"/>
                  <a:t>GFP</a:t>
                </a:r>
                <a:endParaRPr lang="en-US" sz="1100" b="1" dirty="0"/>
              </a:p>
            </p:txBody>
          </p:sp>
          <p:sp>
            <p:nvSpPr>
              <p:cNvPr id="122" name="Rectangle 121"/>
              <p:cNvSpPr/>
              <p:nvPr/>
            </p:nvSpPr>
            <p:spPr>
              <a:xfrm>
                <a:off x="1612814" y="4337717"/>
                <a:ext cx="695791" cy="4572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b="1" dirty="0" smtClean="0"/>
                  <a:t>35T</a:t>
                </a:r>
                <a:endParaRPr lang="en-US" sz="11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378967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240977" y="2950855"/>
            <a:ext cx="6206379" cy="4076921"/>
            <a:chOff x="1240977" y="3466879"/>
            <a:chExt cx="6206379" cy="4076921"/>
          </a:xfrm>
        </p:grpSpPr>
        <p:sp>
          <p:nvSpPr>
            <p:cNvPr id="36" name="Rectangle 30"/>
            <p:cNvSpPr>
              <a:spLocks noChangeArrowheads="1"/>
            </p:cNvSpPr>
            <p:nvPr/>
          </p:nvSpPr>
          <p:spPr bwMode="auto">
            <a:xfrm>
              <a:off x="1346841" y="4527336"/>
              <a:ext cx="1276695" cy="30164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                                                                                                                       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cs typeface="Arial" pitchFamily="34" charset="0"/>
                </a:rPr>
                <a:t> 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ld type (x2)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-GA </a:t>
              </a: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(x5)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      +1A </a:t>
              </a: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(x3)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+1T </a:t>
              </a: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(x2) 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3960211" y="5588947"/>
              <a:ext cx="2011680" cy="77546"/>
              <a:chOff x="3614808" y="4141149"/>
              <a:chExt cx="2011680" cy="77558"/>
            </a:xfrm>
          </p:grpSpPr>
          <p:cxnSp>
            <p:nvCxnSpPr>
              <p:cNvPr id="39" name="Straight Connector 38"/>
              <p:cNvCxnSpPr/>
              <p:nvPr/>
            </p:nvCxnSpPr>
            <p:spPr>
              <a:xfrm>
                <a:off x="3614808" y="4141149"/>
                <a:ext cx="201168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2" name="Down Arrow 61"/>
              <p:cNvSpPr/>
              <p:nvPr/>
            </p:nvSpPr>
            <p:spPr>
              <a:xfrm rot="10800000" flipH="1">
                <a:off x="5257801" y="4169441"/>
                <a:ext cx="63265" cy="4926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3878008" y="6104462"/>
              <a:ext cx="2194560" cy="76974"/>
              <a:chOff x="3925456" y="4656661"/>
              <a:chExt cx="2194560" cy="76974"/>
            </a:xfrm>
          </p:grpSpPr>
          <p:cxnSp>
            <p:nvCxnSpPr>
              <p:cNvPr id="64" name="Straight Connector 63"/>
              <p:cNvCxnSpPr/>
              <p:nvPr/>
            </p:nvCxnSpPr>
            <p:spPr>
              <a:xfrm>
                <a:off x="3925456" y="4656661"/>
                <a:ext cx="219456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5" name="Down Arrow 64"/>
              <p:cNvSpPr/>
              <p:nvPr/>
            </p:nvSpPr>
            <p:spPr>
              <a:xfrm rot="10800000" flipH="1">
                <a:off x="5705496" y="4684369"/>
                <a:ext cx="63265" cy="4926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66" name="Group 65"/>
            <p:cNvGrpSpPr/>
            <p:nvPr/>
          </p:nvGrpSpPr>
          <p:grpSpPr>
            <a:xfrm>
              <a:off x="3860535" y="6550114"/>
              <a:ext cx="2194560" cy="79286"/>
              <a:chOff x="3537992" y="5102313"/>
              <a:chExt cx="2350652" cy="79286"/>
            </a:xfrm>
          </p:grpSpPr>
          <p:cxnSp>
            <p:nvCxnSpPr>
              <p:cNvPr id="67" name="Straight Connector 66"/>
              <p:cNvCxnSpPr/>
              <p:nvPr/>
            </p:nvCxnSpPr>
            <p:spPr>
              <a:xfrm>
                <a:off x="3537992" y="5102313"/>
                <a:ext cx="235065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8" name="Down Arrow 67"/>
              <p:cNvSpPr/>
              <p:nvPr/>
            </p:nvSpPr>
            <p:spPr>
              <a:xfrm rot="10800000" flipH="1">
                <a:off x="5455613" y="5132333"/>
                <a:ext cx="63265" cy="4926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5650237" y="3513871"/>
              <a:ext cx="449490" cy="258504"/>
              <a:chOff x="5613831" y="3896048"/>
              <a:chExt cx="449490" cy="258504"/>
            </a:xfrm>
          </p:grpSpPr>
          <p:sp>
            <p:nvSpPr>
              <p:cNvPr id="69" name="Rectangle 68"/>
              <p:cNvSpPr/>
              <p:nvPr/>
            </p:nvSpPr>
            <p:spPr>
              <a:xfrm>
                <a:off x="5613831" y="3896048"/>
                <a:ext cx="449490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NP</a:t>
                </a:r>
              </a:p>
            </p:txBody>
          </p:sp>
          <p:sp>
            <p:nvSpPr>
              <p:cNvPr id="70" name="5-Point Star 69"/>
              <p:cNvSpPr/>
              <p:nvPr/>
            </p:nvSpPr>
            <p:spPr>
              <a:xfrm>
                <a:off x="5791200" y="4108833"/>
                <a:ext cx="45719" cy="45719"/>
              </a:xfrm>
              <a:prstGeom prst="star5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71" name="Straight Connector 70"/>
            <p:cNvCxnSpPr/>
            <p:nvPr/>
          </p:nvCxnSpPr>
          <p:spPr>
            <a:xfrm>
              <a:off x="3850604" y="5067363"/>
              <a:ext cx="2160069" cy="129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73" name="Group 72"/>
            <p:cNvGrpSpPr/>
            <p:nvPr/>
          </p:nvGrpSpPr>
          <p:grpSpPr>
            <a:xfrm>
              <a:off x="1240977" y="3466879"/>
              <a:ext cx="6070678" cy="1333721"/>
              <a:chOff x="701582" y="2125671"/>
              <a:chExt cx="6070678" cy="922135"/>
            </a:xfrm>
          </p:grpSpPr>
          <p:grpSp>
            <p:nvGrpSpPr>
              <p:cNvPr id="77" name="Group 76"/>
              <p:cNvGrpSpPr/>
              <p:nvPr/>
            </p:nvGrpSpPr>
            <p:grpSpPr>
              <a:xfrm>
                <a:off x="701582" y="2125671"/>
                <a:ext cx="6070678" cy="922135"/>
                <a:chOff x="4691799" y="4312226"/>
                <a:chExt cx="6070678" cy="1058413"/>
              </a:xfrm>
            </p:grpSpPr>
            <p:sp>
              <p:nvSpPr>
                <p:cNvPr id="78" name="Rectangle 29"/>
                <p:cNvSpPr>
                  <a:spLocks noChangeArrowheads="1"/>
                </p:cNvSpPr>
                <p:nvPr/>
              </p:nvSpPr>
              <p:spPr bwMode="auto">
                <a:xfrm>
                  <a:off x="6225223" y="4539259"/>
                  <a:ext cx="3681265" cy="71173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GGCTAAGA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TATAGGCGGCGGAGA GAG</a:t>
                  </a:r>
                </a:p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GGCTAAGA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TATAGGCGGCGGA </a:t>
                  </a:r>
                  <a:r>
                    <a:rPr lang="en-US" sz="9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9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  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AG</a:t>
                  </a:r>
                </a:p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GGCTAAGA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TATAGGCGGCGGAGA</a:t>
                  </a:r>
                  <a:r>
                    <a:rPr lang="en-US" sz="9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AG</a:t>
                  </a:r>
                </a:p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GGCTAAGA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CTATAGGCGGCGGAGA</a:t>
                  </a:r>
                  <a:r>
                    <a:rPr lang="en-US" sz="900" b="1" dirty="0">
                      <a:solidFill>
                        <a:srgbClr val="7030A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</a:t>
                  </a:r>
                  <a:r>
                    <a:rPr lang="en-US" sz="9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AG</a:t>
                  </a:r>
                </a:p>
                <a:p>
                  <a:endPara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                                                                                                                 </a:t>
                  </a:r>
                </a:p>
                <a:p>
                  <a:pPr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     </a:t>
                  </a:r>
                  <a:endParaRPr lang="en-US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9" name="Rectangle 30"/>
                <p:cNvSpPr>
                  <a:spLocks noChangeArrowheads="1"/>
                </p:cNvSpPr>
                <p:nvPr/>
              </p:nvSpPr>
              <p:spPr bwMode="auto">
                <a:xfrm>
                  <a:off x="4691799" y="4312226"/>
                  <a:ext cx="1368247" cy="105841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                                                                                                                         </a:t>
                  </a: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 </a:t>
                  </a: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Wild type (x2) </a:t>
                  </a: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srgbClr val="7030A0"/>
                      </a:solidFill>
                      <a:latin typeface="Arial" pitchFamily="34" charset="0"/>
                      <a:cs typeface="Arial" pitchFamily="34" charset="0"/>
                    </a:rPr>
                    <a:t>-GA </a:t>
                  </a: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(x5)</a:t>
                  </a: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srgbClr val="7030A0"/>
                      </a:solidFill>
                      <a:latin typeface="Arial" pitchFamily="34" charset="0"/>
                      <a:cs typeface="Arial" pitchFamily="34" charset="0"/>
                    </a:rPr>
                    <a:t>+1A </a:t>
                  </a: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(x3) </a:t>
                  </a: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srgbClr val="7030A0"/>
                      </a:solidFill>
                      <a:latin typeface="Arial" pitchFamily="34" charset="0"/>
                      <a:cs typeface="Arial" pitchFamily="34" charset="0"/>
                    </a:rPr>
                    <a:t>+1T </a:t>
                  </a: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(x2) </a:t>
                  </a: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sz="900" b="1" dirty="0">
                    <a:latin typeface="Arial" pitchFamily="34" charset="0"/>
                    <a:cs typeface="Arial" pitchFamily="34" charset="0"/>
                  </a:endParaRP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srgbClr val="7030A0"/>
                      </a:solidFill>
                      <a:latin typeface="Arial" pitchFamily="34" charset="0"/>
                      <a:cs typeface="Arial" pitchFamily="34" charset="0"/>
                    </a:rPr>
                    <a:t>             </a:t>
                  </a:r>
                  <a:endParaRPr lang="en-US" sz="11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  <a:p>
                  <a:pPr algn="r" fontAlgn="base">
                    <a:spcBef>
                      <a:spcPct val="0"/>
                    </a:spcBef>
                    <a:spcAft>
                      <a:spcPts val="1000"/>
                    </a:spcAft>
                  </a:pPr>
                  <a:endParaRPr lang="en-US" sz="11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0" name="Rectangle 29"/>
                <p:cNvSpPr>
                  <a:spLocks noChangeArrowheads="1"/>
                </p:cNvSpPr>
                <p:nvPr/>
              </p:nvSpPr>
              <p:spPr bwMode="auto">
                <a:xfrm>
                  <a:off x="8854367" y="4429456"/>
                  <a:ext cx="1908110" cy="94118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en-US" sz="900" b="1" dirty="0">
                      <a:solidFill>
                        <a:prstClr val="black"/>
                      </a:solidFill>
                      <a:latin typeface="Arial" pitchFamily="34" charset="0"/>
                      <a:cs typeface="Arial" pitchFamily="34" charset="0"/>
                    </a:rPr>
                    <a:t>                                                                                                                         </a:t>
                  </a:r>
                </a:p>
                <a:p>
                  <a:r>
                    <a:rPr lang="en-US" sz="900" b="1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G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CTGCAAGA  </a:t>
                  </a:r>
                </a:p>
                <a:p>
                  <a:r>
                    <a:rPr lang="en-US" sz="900" b="1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G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CTGCAAGA</a:t>
                  </a:r>
                </a:p>
                <a:p>
                  <a:r>
                    <a:rPr lang="en-US" sz="900" b="1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G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CTGCAAGA</a:t>
                  </a:r>
                </a:p>
                <a:p>
                  <a:r>
                    <a:rPr lang="en-US" sz="900" b="1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GG</a:t>
                  </a:r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GCTGCAAGA</a:t>
                  </a:r>
                </a:p>
                <a:p>
                  <a:r>
                    <a:rPr lang="en-US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       </a:t>
                  </a:r>
                </a:p>
                <a:p>
                  <a:endParaRPr lang="en-US" sz="9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  <a:p>
                  <a:pPr algn="r" fontAlgn="base">
                    <a:spcBef>
                      <a:spcPct val="0"/>
                    </a:spcBef>
                    <a:spcAft>
                      <a:spcPct val="0"/>
                    </a:spcAft>
                  </a:pPr>
                  <a:endParaRPr lang="en-US" sz="900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75" name="TextBox 74"/>
              <p:cNvSpPr txBox="1"/>
              <p:nvPr/>
            </p:nvSpPr>
            <p:spPr>
              <a:xfrm>
                <a:off x="4854185" y="2245744"/>
                <a:ext cx="454959" cy="15959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PAM  </a:t>
                </a:r>
                <a:r>
                  <a:rPr lang="en-US" sz="900" b="1" dirty="0" smtClean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                                                </a:t>
                </a:r>
                <a:endPara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81" name="Picture 8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83857" y="6200101"/>
              <a:ext cx="4663499" cy="346494"/>
            </a:xfrm>
            <a:prstGeom prst="rect">
              <a:avLst/>
            </a:prstGeom>
          </p:spPr>
        </p:pic>
        <p:pic>
          <p:nvPicPr>
            <p:cNvPr id="82" name="Picture 8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24885" y="5257382"/>
              <a:ext cx="4602539" cy="303937"/>
            </a:xfrm>
            <a:prstGeom prst="rect">
              <a:avLst/>
            </a:prstGeom>
          </p:spPr>
        </p:pic>
        <p:pic>
          <p:nvPicPr>
            <p:cNvPr id="83" name="Picture 8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24885" y="5684265"/>
              <a:ext cx="4622471" cy="392353"/>
            </a:xfrm>
            <a:prstGeom prst="rect">
              <a:avLst/>
            </a:prstGeom>
          </p:spPr>
        </p:pic>
        <p:pic>
          <p:nvPicPr>
            <p:cNvPr id="84" name="Picture 8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87665" y="4622522"/>
              <a:ext cx="4613970" cy="427632"/>
            </a:xfrm>
            <a:prstGeom prst="rect">
              <a:avLst/>
            </a:prstGeom>
          </p:spPr>
        </p:pic>
      </p:grpSp>
      <p:grpSp>
        <p:nvGrpSpPr>
          <p:cNvPr id="2" name="Group 1"/>
          <p:cNvGrpSpPr/>
          <p:nvPr/>
        </p:nvGrpSpPr>
        <p:grpSpPr>
          <a:xfrm>
            <a:off x="1240977" y="-59924"/>
            <a:ext cx="6150424" cy="3010616"/>
            <a:chOff x="1240977" y="265984"/>
            <a:chExt cx="6150424" cy="3010616"/>
          </a:xfrm>
        </p:grpSpPr>
        <p:sp>
          <p:nvSpPr>
            <p:cNvPr id="53" name="Rectangle 30"/>
            <p:cNvSpPr>
              <a:spLocks noChangeArrowheads="1"/>
            </p:cNvSpPr>
            <p:nvPr/>
          </p:nvSpPr>
          <p:spPr bwMode="auto">
            <a:xfrm>
              <a:off x="1240977" y="1481885"/>
              <a:ext cx="1318260" cy="16082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                                                                                                                        </a:t>
              </a:r>
              <a:r>
                <a:rPr lang="en-US" sz="900" b="1" dirty="0">
                  <a:solidFill>
                    <a:prstClr val="black"/>
                  </a:solidFill>
                  <a:cs typeface="Arial" pitchFamily="34" charset="0"/>
                </a:rPr>
                <a:t> 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ild type (x1)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-GAGA</a:t>
              </a:r>
              <a:r>
                <a:rPr lang="en-US" sz="9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x2)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srgbClr val="7030A0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-GA </a:t>
              </a: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(x5)</a:t>
              </a: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endParaRPr lang="en-US" sz="9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     </a:t>
              </a:r>
              <a:endParaRPr lang="en-US" sz="900" b="1" dirty="0">
                <a:solidFill>
                  <a:prstClr val="black"/>
                </a:solidFill>
                <a:latin typeface="Arial" pitchFamily="34" charset="0"/>
                <a:cs typeface="Arial" pitchFamily="34" charset="0"/>
              </a:endParaRPr>
            </a:p>
            <a:p>
              <a:pPr algn="r"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rPr>
                <a:t>+1A </a:t>
              </a:r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(x3)</a:t>
              </a:r>
              <a:endParaRPr lang="en-US" sz="9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3925458" y="2741347"/>
              <a:ext cx="2011680" cy="77546"/>
              <a:chOff x="3614808" y="4141149"/>
              <a:chExt cx="2011680" cy="77558"/>
            </a:xfrm>
          </p:grpSpPr>
          <p:cxnSp>
            <p:nvCxnSpPr>
              <p:cNvPr id="47" name="Straight Connector 46"/>
              <p:cNvCxnSpPr/>
              <p:nvPr/>
            </p:nvCxnSpPr>
            <p:spPr>
              <a:xfrm>
                <a:off x="3614808" y="4141149"/>
                <a:ext cx="201168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8" name="Down Arrow 47"/>
              <p:cNvSpPr/>
              <p:nvPr/>
            </p:nvSpPr>
            <p:spPr>
              <a:xfrm rot="10800000" flipH="1">
                <a:off x="5198551" y="4169441"/>
                <a:ext cx="63265" cy="4926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3825782" y="3197314"/>
              <a:ext cx="2194560" cy="79286"/>
              <a:chOff x="3537992" y="5102313"/>
              <a:chExt cx="2350652" cy="79286"/>
            </a:xfrm>
          </p:grpSpPr>
          <p:cxnSp>
            <p:nvCxnSpPr>
              <p:cNvPr id="51" name="Straight Connector 50"/>
              <p:cNvCxnSpPr/>
              <p:nvPr/>
            </p:nvCxnSpPr>
            <p:spPr>
              <a:xfrm>
                <a:off x="3537992" y="5102313"/>
                <a:ext cx="2350652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4" name="Down Arrow 53"/>
              <p:cNvSpPr/>
              <p:nvPr/>
            </p:nvSpPr>
            <p:spPr>
              <a:xfrm rot="10800000" flipH="1">
                <a:off x="5480099" y="5132333"/>
                <a:ext cx="63265" cy="4926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5554825" y="359719"/>
              <a:ext cx="449490" cy="230832"/>
              <a:chOff x="5634835" y="26200"/>
              <a:chExt cx="449490" cy="230832"/>
            </a:xfrm>
          </p:grpSpPr>
          <p:sp>
            <p:nvSpPr>
              <p:cNvPr id="3" name="Rectangle 2"/>
              <p:cNvSpPr/>
              <p:nvPr/>
            </p:nvSpPr>
            <p:spPr>
              <a:xfrm>
                <a:off x="5634835" y="26200"/>
                <a:ext cx="449490" cy="23083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NP</a:t>
                </a:r>
              </a:p>
            </p:txBody>
          </p:sp>
          <p:sp>
            <p:nvSpPr>
              <p:cNvPr id="5" name="5-Point Star 4"/>
              <p:cNvSpPr/>
              <p:nvPr/>
            </p:nvSpPr>
            <p:spPr>
              <a:xfrm>
                <a:off x="5848539" y="207861"/>
                <a:ext cx="45719" cy="45719"/>
              </a:xfrm>
              <a:prstGeom prst="star5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764344" y="1371601"/>
              <a:ext cx="4625399" cy="458096"/>
            </a:xfrm>
            <a:prstGeom prst="rect">
              <a:avLst/>
            </a:prstGeom>
          </p:spPr>
        </p:pic>
        <p:cxnSp>
          <p:nvCxnSpPr>
            <p:cNvPr id="40" name="Straight Connector 39"/>
            <p:cNvCxnSpPr/>
            <p:nvPr/>
          </p:nvCxnSpPr>
          <p:spPr>
            <a:xfrm>
              <a:off x="3866731" y="1847488"/>
              <a:ext cx="2160069" cy="129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748593" y="2847301"/>
              <a:ext cx="4641150" cy="319995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741484" y="1873464"/>
              <a:ext cx="4625399" cy="384058"/>
            </a:xfrm>
            <a:prstGeom prst="rect">
              <a:avLst/>
            </a:prstGeom>
          </p:spPr>
        </p:pic>
        <p:grpSp>
          <p:nvGrpSpPr>
            <p:cNvPr id="55" name="Group 54"/>
            <p:cNvGrpSpPr/>
            <p:nvPr/>
          </p:nvGrpSpPr>
          <p:grpSpPr>
            <a:xfrm>
              <a:off x="3946125" y="2286001"/>
              <a:ext cx="1874520" cy="74007"/>
              <a:chOff x="3614808" y="4141149"/>
              <a:chExt cx="1874520" cy="74018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>
                <a:off x="3614808" y="4141149"/>
                <a:ext cx="187452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8" name="Down Arrow 57"/>
              <p:cNvSpPr/>
              <p:nvPr/>
            </p:nvSpPr>
            <p:spPr>
              <a:xfrm rot="10800000" flipH="1">
                <a:off x="5115214" y="4169441"/>
                <a:ext cx="45719" cy="45726"/>
              </a:xfrm>
              <a:prstGeom prst="down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1430756" y="265984"/>
              <a:ext cx="5782545" cy="1181817"/>
              <a:chOff x="4943720" y="4313121"/>
              <a:chExt cx="5782545" cy="937867"/>
            </a:xfrm>
          </p:grpSpPr>
          <p:sp>
            <p:nvSpPr>
              <p:cNvPr id="52" name="Rectangle 29"/>
              <p:cNvSpPr>
                <a:spLocks noChangeArrowheads="1"/>
              </p:cNvSpPr>
              <p:nvPr/>
            </p:nvSpPr>
            <p:spPr bwMode="auto">
              <a:xfrm>
                <a:off x="6225223" y="4539258"/>
                <a:ext cx="3681265" cy="7117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GGGCTAAGA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TATAGGCGGCGGAGA GAG</a:t>
                </a:r>
              </a:p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GGGCTAAGA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TATAGGCGGCG</a:t>
                </a:r>
                <a:r>
                  <a: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- 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 -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GAG</a:t>
                </a:r>
              </a:p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GGGCTAAGA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TATAGGCGGCGGA </a:t>
                </a:r>
                <a:r>
                  <a: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  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G</a:t>
                </a:r>
              </a:p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GGGCTAAGA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TATAGGCGGCGGAGA</a:t>
                </a:r>
                <a:r>
                  <a:rPr lang="en-US" sz="900" b="1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G</a:t>
                </a:r>
              </a:p>
              <a:p>
                <a:endParaRPr lang="en-US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endParaRPr lang="en-US" sz="9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                                                                                                                </a:t>
                </a: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    </a:t>
                </a:r>
                <a:endParaRPr lang="en-US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0" name="Rectangle 30"/>
              <p:cNvSpPr>
                <a:spLocks noChangeArrowheads="1"/>
              </p:cNvSpPr>
              <p:nvPr/>
            </p:nvSpPr>
            <p:spPr bwMode="auto">
              <a:xfrm>
                <a:off x="4943720" y="4313121"/>
                <a:ext cx="1174201" cy="7482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                                                                                                                        </a:t>
                </a:r>
              </a:p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</a:t>
                </a:r>
              </a:p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Wild type (x1) </a:t>
                </a:r>
              </a:p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srgbClr val="7030A0"/>
                    </a:solidFill>
                    <a:latin typeface="Arial" pitchFamily="34" charset="0"/>
                    <a:cs typeface="Arial" pitchFamily="34" charset="0"/>
                  </a:rPr>
                  <a:t>-GAGA</a:t>
                </a: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(x2)</a:t>
                </a:r>
                <a:endParaRPr lang="en-US" sz="900" b="1" dirty="0">
                  <a:solidFill>
                    <a:srgbClr val="7030A0"/>
                  </a:solidFill>
                  <a:latin typeface="Arial" pitchFamily="34" charset="0"/>
                  <a:cs typeface="Arial" pitchFamily="34" charset="0"/>
                </a:endParaRPr>
              </a:p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srgbClr val="7030A0"/>
                    </a:solidFill>
                    <a:latin typeface="Arial" pitchFamily="34" charset="0"/>
                    <a:cs typeface="Arial" pitchFamily="34" charset="0"/>
                  </a:rPr>
                  <a:t>-GA </a:t>
                </a: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(x5)</a:t>
                </a:r>
              </a:p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srgbClr val="7030A0"/>
                    </a:solidFill>
                    <a:latin typeface="Arial" pitchFamily="34" charset="0"/>
                    <a:cs typeface="Arial" pitchFamily="34" charset="0"/>
                  </a:rPr>
                  <a:t>     +1A </a:t>
                </a: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(x3)</a:t>
                </a:r>
                <a:endParaRPr lang="en-US" sz="11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endParaRPr lang="en-US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1" name="Rectangle 29"/>
              <p:cNvSpPr>
                <a:spLocks noChangeArrowheads="1"/>
              </p:cNvSpPr>
              <p:nvPr/>
            </p:nvSpPr>
            <p:spPr bwMode="auto">
              <a:xfrm>
                <a:off x="8818155" y="4429457"/>
                <a:ext cx="1908110" cy="7274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b="1" dirty="0">
                    <a:solidFill>
                      <a:prstClr val="black"/>
                    </a:solidFill>
                    <a:latin typeface="Arial" pitchFamily="34" charset="0"/>
                    <a:cs typeface="Arial" pitchFamily="34" charset="0"/>
                  </a:rPr>
                  <a:t>                                                                                                                         </a:t>
                </a:r>
              </a:p>
              <a:p>
                <a:r>
                  <a:rPr lang="en-US" sz="900" b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GG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GCTGCAAGA  </a:t>
                </a:r>
              </a:p>
              <a:p>
                <a:r>
                  <a:rPr lang="en-US" sz="900" b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GG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GCTGCAAGA</a:t>
                </a:r>
              </a:p>
              <a:p>
                <a:r>
                  <a:rPr lang="en-US" sz="900" b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GG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TCTGCAAGA</a:t>
                </a:r>
              </a:p>
              <a:p>
                <a:r>
                  <a:rPr lang="en-US" sz="900" b="1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GGG</a:t>
                </a:r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GCTGCAAGA</a:t>
                </a:r>
              </a:p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</a:t>
                </a:r>
              </a:p>
              <a:p>
                <a:endParaRPr lang="en-US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  <a:p>
                <a:pPr algn="r" fontAlgn="base">
                  <a:spcBef>
                    <a:spcPct val="0"/>
                  </a:spcBef>
                  <a:spcAft>
                    <a:spcPct val="0"/>
                  </a:spcAft>
                </a:pPr>
                <a:endParaRPr lang="en-US" sz="900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3" name="TextBox 42"/>
            <p:cNvSpPr txBox="1"/>
            <p:nvPr/>
          </p:nvSpPr>
          <p:spPr>
            <a:xfrm>
              <a:off x="5291002" y="422816"/>
              <a:ext cx="6876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prstClr val="black"/>
                  </a:solidFill>
                  <a:latin typeface="Arial" pitchFamily="34" charset="0"/>
                  <a:cs typeface="Arial" pitchFamily="34" charset="0"/>
                </a:rPr>
                <a:t>PAM                                                  </a:t>
              </a:r>
            </a:p>
          </p:txBody>
        </p:sp>
        <p:pic>
          <p:nvPicPr>
            <p:cNvPr id="87" name="Picture 86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743142" y="2381251"/>
              <a:ext cx="4648259" cy="337923"/>
            </a:xfrm>
            <a:prstGeom prst="rect">
              <a:avLst/>
            </a:prstGeom>
          </p:spPr>
        </p:pic>
      </p:grpSp>
      <p:sp>
        <p:nvSpPr>
          <p:cNvPr id="89" name="Rectangle 31"/>
          <p:cNvSpPr>
            <a:spLocks noChangeArrowheads="1"/>
          </p:cNvSpPr>
          <p:nvPr/>
        </p:nvSpPr>
        <p:spPr bwMode="auto">
          <a:xfrm>
            <a:off x="1214307" y="550942"/>
            <a:ext cx="1129190" cy="44986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ts val="500"/>
              </a:spcBef>
              <a:spcAft>
                <a:spcPts val="500"/>
              </a:spcAft>
            </a:pPr>
            <a:r>
              <a:rPr lang="en-US" sz="9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A</a:t>
            </a: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r>
              <a:rPr lang="en-US" sz="9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B</a:t>
            </a: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r>
              <a:rPr lang="en-US" sz="9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endParaRPr lang="en-US" sz="900" b="1" dirty="0">
              <a:solidFill>
                <a:srgbClr val="000000"/>
              </a:solidFill>
              <a:latin typeface="Arial" pitchFamily="34" charset="0"/>
              <a:cs typeface="Arial" pitchFamily="34" charset="0"/>
            </a:endParaRPr>
          </a:p>
          <a:p>
            <a:pPr fontAlgn="base">
              <a:spcBef>
                <a:spcPts val="500"/>
              </a:spcBef>
              <a:spcAft>
                <a:spcPts val="500"/>
              </a:spcAft>
            </a:pPr>
            <a:r>
              <a:rPr lang="en-US" sz="9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D</a:t>
            </a:r>
            <a:endParaRPr lang="en-US" sz="9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34154" y="6156356"/>
            <a:ext cx="82929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chromatograms of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LOB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mutations in D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9 and D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. 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chromatogram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LOB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its mutations in D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 transgenic plant (a, b) and #D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transgenic plant (c, d). The targeted sequence with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LOB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shown by black lines, and the mutant site was pointed out by an arrow. Star indicates SNP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6240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/>
          <p:nvPr/>
        </p:nvSpPr>
        <p:spPr>
          <a:xfrm>
            <a:off x="-856195" y="2701101"/>
            <a:ext cx="3642515" cy="4750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48064" y="4707577"/>
            <a:ext cx="83835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T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 six Duncan transgenic lines showing differential resistance to 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ys post inoculation with Xcc (5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FU/m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e cank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mptoms were observed on normal grapefruit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aseline="-25000" dirty="0"/>
              <a:t>LO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aseline="-25000" dirty="0"/>
              <a:t>LO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Reduced canker symptoms were present on D</a:t>
            </a:r>
            <a:r>
              <a:rPr lang="en-US" sz="1200" baseline="-25000" dirty="0"/>
              <a:t>LO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aseline="-25000" dirty="0"/>
              <a:t>LO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. The pustules appeared on D</a:t>
            </a:r>
            <a:r>
              <a:rPr lang="en-US" sz="1200" baseline="-25000" dirty="0"/>
              <a:t>LO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baseline="-25000" dirty="0"/>
              <a:t>LO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448064" y="3811923"/>
            <a:ext cx="8383510" cy="4750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T           D</a:t>
            </a:r>
            <a:r>
              <a:rPr lang="en-US" sz="16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                 D</a:t>
            </a:r>
            <a:r>
              <a:rPr lang="en-US" sz="16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       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b="1" baseline="-25000" smtClean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9         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          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b="1" baseline="-25000" smtClean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11            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6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6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197492">
            <a:off x="-698809" y="1450203"/>
            <a:ext cx="2666949" cy="128088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4401458" y="1507748"/>
            <a:ext cx="2506215" cy="122746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3045898" y="1374445"/>
            <a:ext cx="2810100" cy="119018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 flipV="1">
            <a:off x="5574440" y="1351810"/>
            <a:ext cx="2608690" cy="126501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400000">
            <a:off x="6737073" y="1428100"/>
            <a:ext cx="2745443" cy="124918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5580512">
            <a:off x="469837" y="1289500"/>
            <a:ext cx="2857785" cy="136007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5700817">
            <a:off x="1855683" y="1329051"/>
            <a:ext cx="2722658" cy="13615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47575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Rectangle 81"/>
          <p:cNvSpPr/>
          <p:nvPr/>
        </p:nvSpPr>
        <p:spPr>
          <a:xfrm>
            <a:off x="1888773" y="2043359"/>
            <a:ext cx="4876800" cy="4750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WT                                      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9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                                               D</a:t>
            </a:r>
            <a:r>
              <a:rPr lang="en-US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1736247" y="5105878"/>
            <a:ext cx="7496365" cy="4750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9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                                        D</a:t>
            </a:r>
            <a:r>
              <a:rPr lang="en-US" sz="9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                                       </a:t>
            </a:r>
            <a:r>
              <a:rPr lang="en-US" sz="900" b="1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900" b="1" baseline="-2500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900" b="1" smtClean="0">
                <a:latin typeface="Arial" panose="020B0604020202020204" pitchFamily="34" charset="0"/>
                <a:cs typeface="Arial" panose="020B0604020202020204" pitchFamily="34" charset="0"/>
              </a:rPr>
              <a:t>11                                                    D</a:t>
            </a:r>
            <a:r>
              <a:rPr lang="en-US" sz="900" b="1" baseline="-25000">
                <a:latin typeface="Arial" panose="020B0604020202020204" pitchFamily="34" charset="0"/>
                <a:cs typeface="Arial" panose="020B0604020202020204" pitchFamily="34" charset="0"/>
              </a:rPr>
              <a:t>LOB</a:t>
            </a:r>
            <a:r>
              <a:rPr lang="en-US" sz="900" b="1" smtClean="0">
                <a:latin typeface="Arial" panose="020B0604020202020204" pitchFamily="34" charset="0"/>
                <a:cs typeface="Arial" panose="020B0604020202020204" pitchFamily="34" charset="0"/>
              </a:rPr>
              <a:t>12 </a:t>
            </a:r>
            <a:endParaRPr lang="en-US" sz="900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4566" y="62155"/>
            <a:ext cx="1550321" cy="216857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26739" y="91300"/>
            <a:ext cx="1408174" cy="220960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9859897">
            <a:off x="4484607" y="121862"/>
            <a:ext cx="1910789" cy="202121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485110">
            <a:off x="1213147" y="3064159"/>
            <a:ext cx="1691642" cy="226675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55297" y="2945269"/>
            <a:ext cx="1490025" cy="245119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333615">
            <a:off x="4252533" y="2945268"/>
            <a:ext cx="1669188" cy="245119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9356697">
            <a:off x="6050226" y="2820734"/>
            <a:ext cx="1692188" cy="260759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15636" y="5866646"/>
            <a:ext cx="80666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visible phenotypic changes for GFP-p1380N-Cas9/sgRNA:cslob1-transformed Duncan grapefruit lin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FP-p1380N-Cas9/sgRNA:cslob1-transformed plants were grown in glasshouse.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5067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128</TotalTime>
  <Words>455</Words>
  <Application>Microsoft Office PowerPoint</Application>
  <PresentationFormat>On-screen Show (4:3)</PresentationFormat>
  <Paragraphs>125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y of Florid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,Hongge</dc:creator>
  <cp:lastModifiedBy>Wang,Nian</cp:lastModifiedBy>
  <cp:revision>1635</cp:revision>
  <cp:lastPrinted>2016-06-07T17:42:20Z</cp:lastPrinted>
  <dcterms:created xsi:type="dcterms:W3CDTF">2013-01-31T16:30:45Z</dcterms:created>
  <dcterms:modified xsi:type="dcterms:W3CDTF">2016-11-07T22:54:32Z</dcterms:modified>
</cp:coreProperties>
</file>